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 Schaffer" userId="30379af1-9b08-43f5-b0a6-5fbc9da7bcf5" providerId="ADAL" clId="{FABE37CF-652B-4264-B476-C6F140320000}"/>
    <pc:docChg chg="delSld">
      <pc:chgData name="Robert Schaffer" userId="30379af1-9b08-43f5-b0a6-5fbc9da7bcf5" providerId="ADAL" clId="{FABE37CF-652B-4264-B476-C6F140320000}" dt="2025-01-06T01:17:06.066" v="0" actId="47"/>
      <pc:docMkLst>
        <pc:docMk/>
      </pc:docMkLst>
      <pc:sldChg chg="del">
        <pc:chgData name="Robert Schaffer" userId="30379af1-9b08-43f5-b0a6-5fbc9da7bcf5" providerId="ADAL" clId="{FABE37CF-652B-4264-B476-C6F140320000}" dt="2025-01-06T01:17:06.066" v="0" actId="47"/>
        <pc:sldMkLst>
          <pc:docMk/>
          <pc:sldMk cId="1090110272" sldId="262"/>
        </pc:sldMkLst>
      </pc:sldChg>
      <pc:sldChg chg="del">
        <pc:chgData name="Robert Schaffer" userId="30379af1-9b08-43f5-b0a6-5fbc9da7bcf5" providerId="ADAL" clId="{FABE37CF-652B-4264-B476-C6F140320000}" dt="2025-01-06T01:17:06.066" v="0" actId="47"/>
        <pc:sldMkLst>
          <pc:docMk/>
          <pc:sldMk cId="349587037" sldId="266"/>
        </pc:sldMkLst>
      </pc:sldChg>
      <pc:sldChg chg="del">
        <pc:chgData name="Robert Schaffer" userId="30379af1-9b08-43f5-b0a6-5fbc9da7bcf5" providerId="ADAL" clId="{FABE37CF-652B-4264-B476-C6F140320000}" dt="2025-01-06T01:17:06.066" v="0" actId="47"/>
        <pc:sldMkLst>
          <pc:docMk/>
          <pc:sldMk cId="93960508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6659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78704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7420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107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95874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44812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35045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95551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01934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6858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2258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3573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21"/>
          <a:stretch/>
        </p:blipFill>
        <p:spPr>
          <a:xfrm>
            <a:off x="565571" y="888413"/>
            <a:ext cx="5764696" cy="262937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4107" y="3517790"/>
            <a:ext cx="8659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/>
              <a:t>Open flower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198041" y="3517790"/>
            <a:ext cx="6142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/>
              <a:t>12 DAP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21592" y="3517790"/>
            <a:ext cx="6142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/>
              <a:t>60 DAP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55935" y="3517790"/>
            <a:ext cx="6832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/>
              <a:t>100 DAP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469637" y="3517790"/>
            <a:ext cx="6832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/>
              <a:t>130 DAP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6844E96-BD79-9FDB-1A47-4B91C74DE6F9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t="1" b="2951"/>
          <a:stretch/>
        </p:blipFill>
        <p:spPr>
          <a:xfrm>
            <a:off x="2030009" y="4811499"/>
            <a:ext cx="540000" cy="8364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8F0E3B0-09D0-CD84-B1F7-A4906E5630F5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t="1" b="1436"/>
          <a:stretch/>
        </p:blipFill>
        <p:spPr>
          <a:xfrm>
            <a:off x="862751" y="4233420"/>
            <a:ext cx="540000" cy="141932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7C8012B-AA61-51D2-CFE6-AC5F0A410018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b="1789"/>
          <a:stretch/>
        </p:blipFill>
        <p:spPr>
          <a:xfrm>
            <a:off x="1479999" y="4238513"/>
            <a:ext cx="540000" cy="141422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C80E15C-0DE5-E212-5C91-0387193A7696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b="1601"/>
          <a:stretch/>
        </p:blipFill>
        <p:spPr>
          <a:xfrm>
            <a:off x="3113838" y="4233420"/>
            <a:ext cx="540000" cy="14169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0706A88-84ED-5227-B6EF-5F319BFA4E5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767"/>
          <a:stretch/>
        </p:blipFill>
        <p:spPr>
          <a:xfrm>
            <a:off x="2598264" y="4233420"/>
            <a:ext cx="499908" cy="141455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B1AACD5-6F89-5424-A21F-96D71A5433C6}"/>
              </a:ext>
            </a:extLst>
          </p:cNvPr>
          <p:cNvPicPr>
            <a:picLocks/>
          </p:cNvPicPr>
          <p:nvPr/>
        </p:nvPicPr>
        <p:blipFill rotWithShape="1">
          <a:blip r:embed="rId8"/>
          <a:srcRect t="-1" b="1927"/>
          <a:stretch/>
        </p:blipFill>
        <p:spPr>
          <a:xfrm>
            <a:off x="3665697" y="4226199"/>
            <a:ext cx="540000" cy="141225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7974927-2F85-2080-02B7-B53C49BA1020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b="2263"/>
          <a:stretch/>
        </p:blipFill>
        <p:spPr>
          <a:xfrm>
            <a:off x="4233222" y="4233420"/>
            <a:ext cx="540000" cy="140741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6C2D9F6-393B-BD45-E4B9-6D2E08F03C50}"/>
              </a:ext>
            </a:extLst>
          </p:cNvPr>
          <p:cNvSpPr txBox="1"/>
          <p:nvPr/>
        </p:nvSpPr>
        <p:spPr>
          <a:xfrm>
            <a:off x="988542" y="4032622"/>
            <a:ext cx="304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R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96889C0-5E8D-E689-4505-76717CDAB73A}"/>
              </a:ext>
            </a:extLst>
          </p:cNvPr>
          <p:cNvSpPr txBox="1"/>
          <p:nvPr/>
        </p:nvSpPr>
        <p:spPr>
          <a:xfrm>
            <a:off x="2147520" y="4032622"/>
            <a:ext cx="2952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A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A8C75B4-C1CB-556C-969B-1D5F3DD2CD4D}"/>
              </a:ext>
            </a:extLst>
          </p:cNvPr>
          <p:cNvSpPr txBox="1"/>
          <p:nvPr/>
        </p:nvSpPr>
        <p:spPr>
          <a:xfrm>
            <a:off x="2702641" y="4032622"/>
            <a:ext cx="2952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A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D9CAF8-B981-FC9A-1B8B-404F68FC8B10}"/>
              </a:ext>
            </a:extLst>
          </p:cNvPr>
          <p:cNvSpPr txBox="1"/>
          <p:nvPr/>
        </p:nvSpPr>
        <p:spPr>
          <a:xfrm>
            <a:off x="3236201" y="4032622"/>
            <a:ext cx="2952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A9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C97E39-45C4-0B99-8A6E-E50E79322087}"/>
              </a:ext>
            </a:extLst>
          </p:cNvPr>
          <p:cNvSpPr txBox="1"/>
          <p:nvPr/>
        </p:nvSpPr>
        <p:spPr>
          <a:xfrm>
            <a:off x="3754482" y="4032622"/>
            <a:ext cx="34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A1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9735127-FE04-2493-8691-F9CD2D77CFCA}"/>
              </a:ext>
            </a:extLst>
          </p:cNvPr>
          <p:cNvSpPr txBox="1"/>
          <p:nvPr/>
        </p:nvSpPr>
        <p:spPr>
          <a:xfrm>
            <a:off x="4337862" y="4032622"/>
            <a:ext cx="34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A1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A91CF1-CB37-6B83-9154-312717755286}"/>
              </a:ext>
            </a:extLst>
          </p:cNvPr>
          <p:cNvSpPr txBox="1"/>
          <p:nvPr/>
        </p:nvSpPr>
        <p:spPr>
          <a:xfrm>
            <a:off x="1597553" y="4032622"/>
            <a:ext cx="304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R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20FD2FF-F56F-3620-48F4-AEEE47003432}"/>
              </a:ext>
            </a:extLst>
          </p:cNvPr>
          <p:cNvSpPr txBox="1"/>
          <p:nvPr/>
        </p:nvSpPr>
        <p:spPr>
          <a:xfrm rot="5400000">
            <a:off x="5281205" y="4743589"/>
            <a:ext cx="703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Branch length (cm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DB06681-77A6-C206-744B-AE78AF54F208}"/>
              </a:ext>
            </a:extLst>
          </p:cNvPr>
          <p:cNvSpPr txBox="1"/>
          <p:nvPr/>
        </p:nvSpPr>
        <p:spPr>
          <a:xfrm rot="5400000">
            <a:off x="5028360" y="4703779"/>
            <a:ext cx="6207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Number of flowers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DAFE2EFB-66CE-87E9-E18A-2F3CE81C16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17844" y="4583350"/>
            <a:ext cx="540000" cy="26283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600BC66-7C10-6633-8304-FC1E23EC33A1}"/>
              </a:ext>
            </a:extLst>
          </p:cNvPr>
          <p:cNvSpPr txBox="1"/>
          <p:nvPr/>
        </p:nvSpPr>
        <p:spPr>
          <a:xfrm>
            <a:off x="5363417" y="4430267"/>
            <a:ext cx="235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36ADCD-02F5-2FC1-EFB5-80168FEB73EE}"/>
              </a:ext>
            </a:extLst>
          </p:cNvPr>
          <p:cNvSpPr txBox="1"/>
          <p:nvPr/>
        </p:nvSpPr>
        <p:spPr>
          <a:xfrm>
            <a:off x="5057087" y="4425149"/>
            <a:ext cx="338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10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55682EF-A547-87EA-EA68-029769900BC6}"/>
              </a:ext>
            </a:extLst>
          </p:cNvPr>
          <p:cNvSpPr txBox="1"/>
          <p:nvPr/>
        </p:nvSpPr>
        <p:spPr>
          <a:xfrm>
            <a:off x="5593765" y="4425149"/>
            <a:ext cx="338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105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C8BD78A-D6B9-22C4-1BF6-4F1822675F9A}"/>
              </a:ext>
            </a:extLst>
          </p:cNvPr>
          <p:cNvCxnSpPr>
            <a:cxnSpLocks/>
          </p:cNvCxnSpPr>
          <p:nvPr/>
        </p:nvCxnSpPr>
        <p:spPr>
          <a:xfrm>
            <a:off x="4930793" y="4226199"/>
            <a:ext cx="0" cy="1412255"/>
          </a:xfrm>
          <a:prstGeom prst="line">
            <a:avLst/>
          </a:prstGeom>
          <a:ln w="1270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FC65704-EF5E-2D46-C566-C128FB5977C7}"/>
              </a:ext>
            </a:extLst>
          </p:cNvPr>
          <p:cNvSpPr txBox="1"/>
          <p:nvPr/>
        </p:nvSpPr>
        <p:spPr>
          <a:xfrm rot="16200000">
            <a:off x="4857424" y="4760773"/>
            <a:ext cx="317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800" dirty="0"/>
              <a:t>2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85E2F0-6372-61CB-02E1-34D52769CBDC}"/>
              </a:ext>
            </a:extLst>
          </p:cNvPr>
          <p:cNvSpPr txBox="1"/>
          <p:nvPr/>
        </p:nvSpPr>
        <p:spPr>
          <a:xfrm>
            <a:off x="51915" y="4007557"/>
            <a:ext cx="566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/>
              <a:t>Year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6AAB26-814F-5036-94B1-5579C51BC385}"/>
              </a:ext>
            </a:extLst>
          </p:cNvPr>
          <p:cNvSpPr txBox="1"/>
          <p:nvPr/>
        </p:nvSpPr>
        <p:spPr>
          <a:xfrm>
            <a:off x="51915" y="530077"/>
            <a:ext cx="566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/>
              <a:t>Year 2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14E48D62-C298-68D8-6E84-D7B3FBCD71E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5571" y="6110050"/>
            <a:ext cx="1440000" cy="116962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F0C59BFB-0EBF-7B34-B5CC-CAB5BC7B05DE}"/>
              </a:ext>
            </a:extLst>
          </p:cNvPr>
          <p:cNvSpPr txBox="1"/>
          <p:nvPr/>
        </p:nvSpPr>
        <p:spPr>
          <a:xfrm>
            <a:off x="51915" y="5751714"/>
            <a:ext cx="1827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mi-NZ" sz="1200" dirty="0" err="1"/>
              <a:t>Comparisons</a:t>
            </a:r>
            <a:r>
              <a:rPr lang="mi-NZ" sz="1200" dirty="0"/>
              <a:t> for </a:t>
            </a:r>
            <a:r>
              <a:rPr lang="mi-NZ" sz="1200" dirty="0" err="1"/>
              <a:t>Figure</a:t>
            </a:r>
            <a:r>
              <a:rPr lang="mi-NZ" sz="1200" dirty="0"/>
              <a:t> 1C</a:t>
            </a:r>
            <a:endParaRPr lang="en-NZ" sz="1200" dirty="0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A78EFBF1-C64E-5E49-61C7-E3C97640242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95863" y="6109693"/>
            <a:ext cx="1440000" cy="1172093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D4429DA1-A638-5DFE-A08D-D84814A3373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18731" y="6110050"/>
            <a:ext cx="1440000" cy="1172093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14F23EC-261F-D6AF-7633-FC5361F377C1}"/>
              </a:ext>
            </a:extLst>
          </p:cNvPr>
          <p:cNvSpPr txBox="1"/>
          <p:nvPr/>
        </p:nvSpPr>
        <p:spPr>
          <a:xfrm>
            <a:off x="117733" y="228031"/>
            <a:ext cx="5073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/>
              <a:t>Additional Data 1. Phenotype of </a:t>
            </a:r>
            <a:r>
              <a:rPr lang="en-NZ" sz="1200" i="1" dirty="0"/>
              <a:t>MADS8</a:t>
            </a:r>
            <a:r>
              <a:rPr lang="en-NZ" sz="1200" dirty="0"/>
              <a:t> overexpression and statistical analysi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FE90640-0690-1287-0271-6265084F8432}"/>
              </a:ext>
            </a:extLst>
          </p:cNvPr>
          <p:cNvSpPr txBox="1"/>
          <p:nvPr/>
        </p:nvSpPr>
        <p:spPr>
          <a:xfrm>
            <a:off x="258618" y="7703127"/>
            <a:ext cx="620683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Supplementary Figure </a:t>
            </a:r>
            <a:r>
              <a:rPr lang="en-NZ" sz="1200" b="1" dirty="0" err="1" smtClean="0"/>
              <a:t>S1</a:t>
            </a:r>
            <a:r>
              <a:rPr lang="en-NZ" sz="1200" dirty="0"/>
              <a:t>.  Images of line A11 showing unique flowering and fruiting </a:t>
            </a:r>
            <a:r>
              <a:rPr lang="en-NZ" sz="1200"/>
              <a:t>in </a:t>
            </a:r>
            <a:r>
              <a:rPr lang="en-NZ" sz="1200" smtClean="0"/>
              <a:t>year </a:t>
            </a:r>
            <a:r>
              <a:rPr lang="en-NZ" sz="1200" dirty="0"/>
              <a:t>2.  Year 3 data showing growth and flowering of the pruned trees.  84% confidence limits of numbers of broken buds along the tree for each tree, the numbers of flowers for broken buds and the length of the branches in each line Non-overlapping 84% confidence limits indicate statistically significant differences at </a:t>
            </a:r>
            <a:r>
              <a:rPr lang="el-GR" sz="1200" dirty="0"/>
              <a:t>α</a:t>
            </a:r>
            <a:r>
              <a:rPr lang="en-US" sz="1200" dirty="0"/>
              <a:t> = 0.05</a:t>
            </a:r>
            <a:r>
              <a:rPr lang="en-NZ" sz="12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60951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3</Words>
  <Application>Microsoft Office PowerPoint</Application>
  <PresentationFormat>A4-Papie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Plant &amp; Foo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Schaffer</dc:creator>
  <cp:lastModifiedBy>Brigitte</cp:lastModifiedBy>
  <cp:revision>9</cp:revision>
  <dcterms:created xsi:type="dcterms:W3CDTF">2021-10-18T00:31:37Z</dcterms:created>
  <dcterms:modified xsi:type="dcterms:W3CDTF">2025-01-22T11:26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d8f3512-c98a-4fbc-ad6e-3260f1cde3f8_Enabled">
    <vt:lpwstr>true</vt:lpwstr>
  </property>
  <property fmtid="{D5CDD505-2E9C-101B-9397-08002B2CF9AE}" pid="3" name="MSIP_Label_8d8f3512-c98a-4fbc-ad6e-3260f1cde3f8_SetDate">
    <vt:lpwstr>2024-10-21T22:09:08Z</vt:lpwstr>
  </property>
  <property fmtid="{D5CDD505-2E9C-101B-9397-08002B2CF9AE}" pid="4" name="MSIP_Label_8d8f3512-c98a-4fbc-ad6e-3260f1cde3f8_Method">
    <vt:lpwstr>Standard</vt:lpwstr>
  </property>
  <property fmtid="{D5CDD505-2E9C-101B-9397-08002B2CF9AE}" pid="5" name="MSIP_Label_8d8f3512-c98a-4fbc-ad6e-3260f1cde3f8_Name">
    <vt:lpwstr>Internal</vt:lpwstr>
  </property>
  <property fmtid="{D5CDD505-2E9C-101B-9397-08002B2CF9AE}" pid="6" name="MSIP_Label_8d8f3512-c98a-4fbc-ad6e-3260f1cde3f8_SiteId">
    <vt:lpwstr>6ca75ef7-2c66-42e7-af2c-6502153a7e3a</vt:lpwstr>
  </property>
  <property fmtid="{D5CDD505-2E9C-101B-9397-08002B2CF9AE}" pid="7" name="MSIP_Label_8d8f3512-c98a-4fbc-ad6e-3260f1cde3f8_ActionId">
    <vt:lpwstr>914ec625-308d-4b51-bd43-6d1de01e539d</vt:lpwstr>
  </property>
  <property fmtid="{D5CDD505-2E9C-101B-9397-08002B2CF9AE}" pid="8" name="MSIP_Label_8d8f3512-c98a-4fbc-ad6e-3260f1cde3f8_ContentBits">
    <vt:lpwstr>0</vt:lpwstr>
  </property>
</Properties>
</file>